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89" r:id="rId2"/>
    <p:sldId id="281" r:id="rId3"/>
  </p:sldIdLst>
  <p:sldSz cx="8120063" cy="10826750" type="B4ISO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391B05C3-B2CA-424A-9E26-0EF023ABD1C3}">
          <p14:sldIdLst>
            <p14:sldId id="289"/>
            <p14:sldId id="281"/>
          </p14:sldIdLst>
        </p14:section>
        <p14:section name="无标题节" id="{2FFE4663-5772-4E79-8114-1CF6D82EC105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dows 用户" initials="W用" lastIdx="1" clrIdx="0">
    <p:extLst>
      <p:ext uri="{19B8F6BF-5375-455C-9EA6-DF929625EA0E}">
        <p15:presenceInfo xmlns:p15="http://schemas.microsoft.com/office/powerpoint/2012/main" userId="Windows 用户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89" autoAdjust="0"/>
    <p:restoredTop sz="95394" autoAdjust="0"/>
  </p:normalViewPr>
  <p:slideViewPr>
    <p:cSldViewPr snapToGrid="0">
      <p:cViewPr varScale="1">
        <p:scale>
          <a:sx n="66" d="100"/>
          <a:sy n="66" d="100"/>
        </p:scale>
        <p:origin x="290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21-&#33267;&#20170;&#38498;-&#26657;&#20854;&#20182;&#25945;&#24072;&#21512;&#20316;&#39033;&#30446;&#36164;&#26009;\&#21016;&#20891;&#39033;&#30446;&#36164;&#26009;2021&#24180;&#20197;&#26469;\2022.07.15-&#20013;&#33647;&#40644;&#37230;&#36136;&#35889;&#37492;&#23450;&#25991;&#29486;-6W\2022.09.03-&#40644;&#37230;&#22797;&#26041;&#25968;&#25454;\2022.09.06-&#40644;&#37230;&#28151;&#21512;&#29289;&#26631;&#20934;&#26354;&#3244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22225" cap="rnd">
                <a:solidFill>
                  <a:schemeClr val="accent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Sheet1!$C$15:$C$20</c:f>
              <c:numCache>
                <c:formatCode>General</c:formatCode>
                <c:ptCount val="6"/>
                <c:pt idx="0">
                  <c:v>1000</c:v>
                </c:pt>
                <c:pt idx="1">
                  <c:v>500</c:v>
                </c:pt>
                <c:pt idx="2">
                  <c:v>200</c:v>
                </c:pt>
                <c:pt idx="3">
                  <c:v>100</c:v>
                </c:pt>
                <c:pt idx="4">
                  <c:v>50</c:v>
                </c:pt>
                <c:pt idx="5">
                  <c:v>10</c:v>
                </c:pt>
              </c:numCache>
            </c:numRef>
          </c:xVal>
          <c:yVal>
            <c:numRef>
              <c:f>Sheet1!$D$15:$D$20</c:f>
              <c:numCache>
                <c:formatCode>General</c:formatCode>
                <c:ptCount val="6"/>
                <c:pt idx="0">
                  <c:v>604000</c:v>
                </c:pt>
                <c:pt idx="1">
                  <c:v>280000</c:v>
                </c:pt>
                <c:pt idx="2">
                  <c:v>94200</c:v>
                </c:pt>
                <c:pt idx="3">
                  <c:v>52900</c:v>
                </c:pt>
                <c:pt idx="4">
                  <c:v>28200</c:v>
                </c:pt>
                <c:pt idx="5">
                  <c:v>61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E28-4E62-B204-73C3CDBD19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443231"/>
        <c:axId val="862439071"/>
      </c:scatterChart>
      <c:valAx>
        <c:axId val="8624432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CH"/>
          </a:p>
        </c:txPr>
        <c:crossAx val="862439071"/>
        <c:crosses val="autoZero"/>
        <c:crossBetween val="midCat"/>
      </c:valAx>
      <c:valAx>
        <c:axId val="862439071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CH"/>
          </a:p>
        </c:txPr>
        <c:crossAx val="8624432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CH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AB4973-C8EC-466A-9604-3BCDF8B0B63C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747EBD-E94D-4B07-A0EE-D93697C5D2F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1839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1pPr>
    <a:lvl2pPr marL="516669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2pPr>
    <a:lvl3pPr marL="1033337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3pPr>
    <a:lvl4pPr marL="1550007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4pPr>
    <a:lvl5pPr marL="2066675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5pPr>
    <a:lvl6pPr marL="2583343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6pPr>
    <a:lvl7pPr marL="3100012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7pPr>
    <a:lvl8pPr marL="3616681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8pPr>
    <a:lvl9pPr marL="4133349" algn="l" defTabSz="1033337" rtl="0" eaLnBrk="1" latinLnBrk="0" hangingPunct="1">
      <a:defRPr sz="13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005" y="1771879"/>
            <a:ext cx="6902054" cy="3769313"/>
          </a:xfrm>
        </p:spPr>
        <p:txBody>
          <a:bodyPr anchor="b"/>
          <a:lstStyle>
            <a:lvl1pPr algn="ctr">
              <a:defRPr sz="532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5008" y="5686551"/>
            <a:ext cx="6090047" cy="2613958"/>
          </a:xfrm>
        </p:spPr>
        <p:txBody>
          <a:bodyPr/>
          <a:lstStyle>
            <a:lvl1pPr marL="0" indent="0" algn="ctr">
              <a:buNone/>
              <a:defRPr sz="2131"/>
            </a:lvl1pPr>
            <a:lvl2pPr marL="405994" indent="0" algn="ctr">
              <a:buNone/>
              <a:defRPr sz="1776"/>
            </a:lvl2pPr>
            <a:lvl3pPr marL="811987" indent="0" algn="ctr">
              <a:buNone/>
              <a:defRPr sz="1598"/>
            </a:lvl3pPr>
            <a:lvl4pPr marL="1217981" indent="0" algn="ctr">
              <a:buNone/>
              <a:defRPr sz="1421"/>
            </a:lvl4pPr>
            <a:lvl5pPr marL="1623974" indent="0" algn="ctr">
              <a:buNone/>
              <a:defRPr sz="1421"/>
            </a:lvl5pPr>
            <a:lvl6pPr marL="2029968" indent="0" algn="ctr">
              <a:buNone/>
              <a:defRPr sz="1421"/>
            </a:lvl6pPr>
            <a:lvl7pPr marL="2435962" indent="0" algn="ctr">
              <a:buNone/>
              <a:defRPr sz="1421"/>
            </a:lvl7pPr>
            <a:lvl8pPr marL="2841955" indent="0" algn="ctr">
              <a:buNone/>
              <a:defRPr sz="1421"/>
            </a:lvl8pPr>
            <a:lvl9pPr marL="3247949" indent="0" algn="ctr">
              <a:buNone/>
              <a:defRPr sz="142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979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757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10920" y="576424"/>
            <a:ext cx="1750889" cy="917517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8255" y="576424"/>
            <a:ext cx="5151165" cy="917517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9521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8587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4026" y="2699172"/>
            <a:ext cx="7003554" cy="4503626"/>
          </a:xfrm>
        </p:spPr>
        <p:txBody>
          <a:bodyPr anchor="b"/>
          <a:lstStyle>
            <a:lvl1pPr>
              <a:defRPr sz="532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4026" y="7245404"/>
            <a:ext cx="7003554" cy="2368351"/>
          </a:xfrm>
        </p:spPr>
        <p:txBody>
          <a:bodyPr/>
          <a:lstStyle>
            <a:lvl1pPr marL="0" indent="0">
              <a:buNone/>
              <a:defRPr sz="2131">
                <a:solidFill>
                  <a:schemeClr val="tx1"/>
                </a:solidFill>
              </a:defRPr>
            </a:lvl1pPr>
            <a:lvl2pPr marL="405994" indent="0">
              <a:buNone/>
              <a:defRPr sz="1776">
                <a:solidFill>
                  <a:schemeClr val="tx1">
                    <a:tint val="75000"/>
                  </a:schemeClr>
                </a:solidFill>
              </a:defRPr>
            </a:lvl2pPr>
            <a:lvl3pPr marL="811987" indent="0">
              <a:buNone/>
              <a:defRPr sz="1598">
                <a:solidFill>
                  <a:schemeClr val="tx1">
                    <a:tint val="75000"/>
                  </a:schemeClr>
                </a:solidFill>
              </a:defRPr>
            </a:lvl3pPr>
            <a:lvl4pPr marL="1217981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4pPr>
            <a:lvl5pPr marL="1623974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5pPr>
            <a:lvl6pPr marL="2029968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6pPr>
            <a:lvl7pPr marL="2435962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7pPr>
            <a:lvl8pPr marL="2841955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8pPr>
            <a:lvl9pPr marL="3247949" indent="0">
              <a:buNone/>
              <a:defRPr sz="14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3638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8254" y="2882121"/>
            <a:ext cx="3451027" cy="68694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0782" y="2882121"/>
            <a:ext cx="3451027" cy="68694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622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576427"/>
            <a:ext cx="7003554" cy="209267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9313" y="2654058"/>
            <a:ext cx="3435167" cy="1300713"/>
          </a:xfrm>
        </p:spPr>
        <p:txBody>
          <a:bodyPr anchor="b"/>
          <a:lstStyle>
            <a:lvl1pPr marL="0" indent="0">
              <a:buNone/>
              <a:defRPr sz="2131" b="1"/>
            </a:lvl1pPr>
            <a:lvl2pPr marL="405994" indent="0">
              <a:buNone/>
              <a:defRPr sz="1776" b="1"/>
            </a:lvl2pPr>
            <a:lvl3pPr marL="811987" indent="0">
              <a:buNone/>
              <a:defRPr sz="1598" b="1"/>
            </a:lvl3pPr>
            <a:lvl4pPr marL="1217981" indent="0">
              <a:buNone/>
              <a:defRPr sz="1421" b="1"/>
            </a:lvl4pPr>
            <a:lvl5pPr marL="1623974" indent="0">
              <a:buNone/>
              <a:defRPr sz="1421" b="1"/>
            </a:lvl5pPr>
            <a:lvl6pPr marL="2029968" indent="0">
              <a:buNone/>
              <a:defRPr sz="1421" b="1"/>
            </a:lvl6pPr>
            <a:lvl7pPr marL="2435962" indent="0">
              <a:buNone/>
              <a:defRPr sz="1421" b="1"/>
            </a:lvl7pPr>
            <a:lvl8pPr marL="2841955" indent="0">
              <a:buNone/>
              <a:defRPr sz="1421" b="1"/>
            </a:lvl8pPr>
            <a:lvl9pPr marL="3247949" indent="0">
              <a:buNone/>
              <a:defRPr sz="142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9313" y="3954771"/>
            <a:ext cx="3435167" cy="5816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10783" y="2654058"/>
            <a:ext cx="3452084" cy="1300713"/>
          </a:xfrm>
        </p:spPr>
        <p:txBody>
          <a:bodyPr anchor="b"/>
          <a:lstStyle>
            <a:lvl1pPr marL="0" indent="0">
              <a:buNone/>
              <a:defRPr sz="2131" b="1"/>
            </a:lvl1pPr>
            <a:lvl2pPr marL="405994" indent="0">
              <a:buNone/>
              <a:defRPr sz="1776" b="1"/>
            </a:lvl2pPr>
            <a:lvl3pPr marL="811987" indent="0">
              <a:buNone/>
              <a:defRPr sz="1598" b="1"/>
            </a:lvl3pPr>
            <a:lvl4pPr marL="1217981" indent="0">
              <a:buNone/>
              <a:defRPr sz="1421" b="1"/>
            </a:lvl4pPr>
            <a:lvl5pPr marL="1623974" indent="0">
              <a:buNone/>
              <a:defRPr sz="1421" b="1"/>
            </a:lvl5pPr>
            <a:lvl6pPr marL="2029968" indent="0">
              <a:buNone/>
              <a:defRPr sz="1421" b="1"/>
            </a:lvl6pPr>
            <a:lvl7pPr marL="2435962" indent="0">
              <a:buNone/>
              <a:defRPr sz="1421" b="1"/>
            </a:lvl7pPr>
            <a:lvl8pPr marL="2841955" indent="0">
              <a:buNone/>
              <a:defRPr sz="1421" b="1"/>
            </a:lvl8pPr>
            <a:lvl9pPr marL="3247949" indent="0">
              <a:buNone/>
              <a:defRPr sz="142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10783" y="3954771"/>
            <a:ext cx="3452084" cy="58168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3549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286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249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721783"/>
            <a:ext cx="2618932" cy="2526242"/>
          </a:xfrm>
        </p:spPr>
        <p:txBody>
          <a:bodyPr anchor="b"/>
          <a:lstStyle>
            <a:lvl1pPr>
              <a:defRPr sz="28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52084" y="1558854"/>
            <a:ext cx="4110782" cy="7694010"/>
          </a:xfrm>
        </p:spPr>
        <p:txBody>
          <a:bodyPr/>
          <a:lstStyle>
            <a:lvl1pPr>
              <a:defRPr sz="2842"/>
            </a:lvl1pPr>
            <a:lvl2pPr>
              <a:defRPr sz="2486"/>
            </a:lvl2pPr>
            <a:lvl3pPr>
              <a:defRPr sz="2131"/>
            </a:lvl3pPr>
            <a:lvl4pPr>
              <a:defRPr sz="1776"/>
            </a:lvl4pPr>
            <a:lvl5pPr>
              <a:defRPr sz="1776"/>
            </a:lvl5pPr>
            <a:lvl6pPr>
              <a:defRPr sz="1776"/>
            </a:lvl6pPr>
            <a:lvl7pPr>
              <a:defRPr sz="1776"/>
            </a:lvl7pPr>
            <a:lvl8pPr>
              <a:defRPr sz="1776"/>
            </a:lvl8pPr>
            <a:lvl9pPr>
              <a:defRPr sz="177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9312" y="3248025"/>
            <a:ext cx="2618932" cy="6017368"/>
          </a:xfrm>
        </p:spPr>
        <p:txBody>
          <a:bodyPr/>
          <a:lstStyle>
            <a:lvl1pPr marL="0" indent="0">
              <a:buNone/>
              <a:defRPr sz="1421"/>
            </a:lvl1pPr>
            <a:lvl2pPr marL="405994" indent="0">
              <a:buNone/>
              <a:defRPr sz="1243"/>
            </a:lvl2pPr>
            <a:lvl3pPr marL="811987" indent="0">
              <a:buNone/>
              <a:defRPr sz="1066"/>
            </a:lvl3pPr>
            <a:lvl4pPr marL="1217981" indent="0">
              <a:buNone/>
              <a:defRPr sz="888"/>
            </a:lvl4pPr>
            <a:lvl5pPr marL="1623974" indent="0">
              <a:buNone/>
              <a:defRPr sz="888"/>
            </a:lvl5pPr>
            <a:lvl6pPr marL="2029968" indent="0">
              <a:buNone/>
              <a:defRPr sz="888"/>
            </a:lvl6pPr>
            <a:lvl7pPr marL="2435962" indent="0">
              <a:buNone/>
              <a:defRPr sz="888"/>
            </a:lvl7pPr>
            <a:lvl8pPr marL="2841955" indent="0">
              <a:buNone/>
              <a:defRPr sz="888"/>
            </a:lvl8pPr>
            <a:lvl9pPr marL="3247949" indent="0">
              <a:buNone/>
              <a:defRPr sz="88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597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9312" y="721783"/>
            <a:ext cx="2618932" cy="2526242"/>
          </a:xfrm>
        </p:spPr>
        <p:txBody>
          <a:bodyPr anchor="b"/>
          <a:lstStyle>
            <a:lvl1pPr>
              <a:defRPr sz="28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52084" y="1558854"/>
            <a:ext cx="4110782" cy="7694010"/>
          </a:xfrm>
        </p:spPr>
        <p:txBody>
          <a:bodyPr anchor="t"/>
          <a:lstStyle>
            <a:lvl1pPr marL="0" indent="0">
              <a:buNone/>
              <a:defRPr sz="2842"/>
            </a:lvl1pPr>
            <a:lvl2pPr marL="405994" indent="0">
              <a:buNone/>
              <a:defRPr sz="2486"/>
            </a:lvl2pPr>
            <a:lvl3pPr marL="811987" indent="0">
              <a:buNone/>
              <a:defRPr sz="2131"/>
            </a:lvl3pPr>
            <a:lvl4pPr marL="1217981" indent="0">
              <a:buNone/>
              <a:defRPr sz="1776"/>
            </a:lvl4pPr>
            <a:lvl5pPr marL="1623974" indent="0">
              <a:buNone/>
              <a:defRPr sz="1776"/>
            </a:lvl5pPr>
            <a:lvl6pPr marL="2029968" indent="0">
              <a:buNone/>
              <a:defRPr sz="1776"/>
            </a:lvl6pPr>
            <a:lvl7pPr marL="2435962" indent="0">
              <a:buNone/>
              <a:defRPr sz="1776"/>
            </a:lvl7pPr>
            <a:lvl8pPr marL="2841955" indent="0">
              <a:buNone/>
              <a:defRPr sz="1776"/>
            </a:lvl8pPr>
            <a:lvl9pPr marL="3247949" indent="0">
              <a:buNone/>
              <a:defRPr sz="177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59312" y="3248025"/>
            <a:ext cx="2618932" cy="6017368"/>
          </a:xfrm>
        </p:spPr>
        <p:txBody>
          <a:bodyPr/>
          <a:lstStyle>
            <a:lvl1pPr marL="0" indent="0">
              <a:buNone/>
              <a:defRPr sz="1421"/>
            </a:lvl1pPr>
            <a:lvl2pPr marL="405994" indent="0">
              <a:buNone/>
              <a:defRPr sz="1243"/>
            </a:lvl2pPr>
            <a:lvl3pPr marL="811987" indent="0">
              <a:buNone/>
              <a:defRPr sz="1066"/>
            </a:lvl3pPr>
            <a:lvl4pPr marL="1217981" indent="0">
              <a:buNone/>
              <a:defRPr sz="888"/>
            </a:lvl4pPr>
            <a:lvl5pPr marL="1623974" indent="0">
              <a:buNone/>
              <a:defRPr sz="888"/>
            </a:lvl5pPr>
            <a:lvl6pPr marL="2029968" indent="0">
              <a:buNone/>
              <a:defRPr sz="888"/>
            </a:lvl6pPr>
            <a:lvl7pPr marL="2435962" indent="0">
              <a:buNone/>
              <a:defRPr sz="888"/>
            </a:lvl7pPr>
            <a:lvl8pPr marL="2841955" indent="0">
              <a:buNone/>
              <a:defRPr sz="888"/>
            </a:lvl8pPr>
            <a:lvl9pPr marL="3247949" indent="0">
              <a:buNone/>
              <a:defRPr sz="88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535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8255" y="576427"/>
            <a:ext cx="7003554" cy="20926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8255" y="2882121"/>
            <a:ext cx="7003554" cy="68694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8254" y="10034796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7B6FA-3A41-4E1C-A0D4-CEED359D3B8D}" type="datetimeFigureOut">
              <a:rPr lang="zh-CN" altLang="en-US" smtClean="0"/>
              <a:t>2024/7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9771" y="10034796"/>
            <a:ext cx="2740521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34795" y="10034796"/>
            <a:ext cx="1827014" cy="57642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5FAD-42FD-4E6C-BC40-91EF3B7880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634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11987" rtl="0" eaLnBrk="1" latinLnBrk="0" hangingPunct="1">
        <a:lnSpc>
          <a:spcPct val="90000"/>
        </a:lnSpc>
        <a:spcBef>
          <a:spcPct val="0"/>
        </a:spcBef>
        <a:buNone/>
        <a:defRPr sz="39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2997" indent="-202997" algn="l" defTabSz="811987" rtl="0" eaLnBrk="1" latinLnBrk="0" hangingPunct="1">
        <a:lnSpc>
          <a:spcPct val="90000"/>
        </a:lnSpc>
        <a:spcBef>
          <a:spcPts val="888"/>
        </a:spcBef>
        <a:buFont typeface="Arial" panose="020B0604020202020204" pitchFamily="34" charset="0"/>
        <a:buChar char="•"/>
        <a:defRPr sz="2486" kern="1200">
          <a:solidFill>
            <a:schemeClr val="tx1"/>
          </a:solidFill>
          <a:latin typeface="+mn-lt"/>
          <a:ea typeface="+mn-ea"/>
          <a:cs typeface="+mn-cs"/>
        </a:defRPr>
      </a:lvl1pPr>
      <a:lvl2pPr marL="608990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2pPr>
      <a:lvl3pPr marL="1014984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776" kern="1200">
          <a:solidFill>
            <a:schemeClr val="tx1"/>
          </a:solidFill>
          <a:latin typeface="+mn-lt"/>
          <a:ea typeface="+mn-ea"/>
          <a:cs typeface="+mn-cs"/>
        </a:defRPr>
      </a:lvl3pPr>
      <a:lvl4pPr marL="1420978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4pPr>
      <a:lvl5pPr marL="1826971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5pPr>
      <a:lvl6pPr marL="2232965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6pPr>
      <a:lvl7pPr marL="2638958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7pPr>
      <a:lvl8pPr marL="3044952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8pPr>
      <a:lvl9pPr marL="3450946" indent="-202997" algn="l" defTabSz="811987" rtl="0" eaLnBrk="1" latinLnBrk="0" hangingPunct="1">
        <a:lnSpc>
          <a:spcPct val="90000"/>
        </a:lnSpc>
        <a:spcBef>
          <a:spcPts val="444"/>
        </a:spcBef>
        <a:buFont typeface="Arial" panose="020B0604020202020204" pitchFamily="34" charset="0"/>
        <a:buChar char="•"/>
        <a:defRPr sz="15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1pPr>
      <a:lvl2pPr marL="405994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2pPr>
      <a:lvl3pPr marL="811987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3pPr>
      <a:lvl4pPr marL="1217981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4pPr>
      <a:lvl5pPr marL="1623974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5pPr>
      <a:lvl6pPr marL="2029968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6pPr>
      <a:lvl7pPr marL="2435962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7pPr>
      <a:lvl8pPr marL="2841955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8pPr>
      <a:lvl9pPr marL="3247949" algn="l" defTabSz="811987" rtl="0" eaLnBrk="1" latinLnBrk="0" hangingPunct="1">
        <a:defRPr sz="15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>
            <a:extLst>
              <a:ext uri="{FF2B5EF4-FFF2-40B4-BE49-F238E27FC236}">
                <a16:creationId xmlns:a16="http://schemas.microsoft.com/office/drawing/2014/main" id="{E2F1B253-A618-EFDE-8C00-9AC40C001CD6}"/>
              </a:ext>
            </a:extLst>
          </p:cNvPr>
          <p:cNvGrpSpPr/>
          <p:nvPr/>
        </p:nvGrpSpPr>
        <p:grpSpPr>
          <a:xfrm>
            <a:off x="-228151" y="-170425"/>
            <a:ext cx="12653005" cy="11937124"/>
            <a:chOff x="-228151" y="-170425"/>
            <a:chExt cx="12653005" cy="11937124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59EE6750-0D18-21DC-D289-47CF47DF78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75" y="0"/>
              <a:ext cx="5668963" cy="2468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>
              <a:extLst>
                <a:ext uri="{FF2B5EF4-FFF2-40B4-BE49-F238E27FC236}">
                  <a16:creationId xmlns:a16="http://schemas.microsoft.com/office/drawing/2014/main" id="{350261F3-A9F7-A9DC-2CF6-5FC7AF2E2DE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75" y="3189101"/>
              <a:ext cx="5686425" cy="2381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35D24FB2-0E33-9E68-27EB-FC189D5705B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75" y="6342909"/>
              <a:ext cx="5668963" cy="2378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9" name="Picture 5">
              <a:extLst>
                <a:ext uri="{FF2B5EF4-FFF2-40B4-BE49-F238E27FC236}">
                  <a16:creationId xmlns:a16="http://schemas.microsoft.com/office/drawing/2014/main" id="{2DFD6C9D-21F3-D5C9-4917-15E20A3AF97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2086" y="0"/>
              <a:ext cx="5686425" cy="24590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0" name="Picture 6">
              <a:extLst>
                <a:ext uri="{FF2B5EF4-FFF2-40B4-BE49-F238E27FC236}">
                  <a16:creationId xmlns:a16="http://schemas.microsoft.com/office/drawing/2014/main" id="{47F71B6A-4EA5-9B36-3B71-5121FAD9EA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2086" y="3189101"/>
              <a:ext cx="5686425" cy="2428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1" name="Picture 7">
              <a:extLst>
                <a:ext uri="{FF2B5EF4-FFF2-40B4-BE49-F238E27FC236}">
                  <a16:creationId xmlns:a16="http://schemas.microsoft.com/office/drawing/2014/main" id="{6B6F2C1B-67CD-FF8A-7DB3-CBF0B72E0DA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22086" y="6342909"/>
              <a:ext cx="5686425" cy="2420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DE87974A-D054-56E2-E8E0-183A5E254F4F}"/>
                </a:ext>
              </a:extLst>
            </p:cNvPr>
            <p:cNvSpPr txBox="1"/>
            <p:nvPr/>
          </p:nvSpPr>
          <p:spPr>
            <a:xfrm rot="16200000">
              <a:off x="-267518" y="-131058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6BB247B2-F191-9B2A-EEE7-AFB62CAEED0A}"/>
                </a:ext>
              </a:extLst>
            </p:cNvPr>
            <p:cNvSpPr txBox="1"/>
            <p:nvPr/>
          </p:nvSpPr>
          <p:spPr>
            <a:xfrm rot="16200000">
              <a:off x="-267518" y="2994934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0B689F9-2B86-C143-9AC8-D7A9D9033090}"/>
                </a:ext>
              </a:extLst>
            </p:cNvPr>
            <p:cNvSpPr txBox="1"/>
            <p:nvPr/>
          </p:nvSpPr>
          <p:spPr>
            <a:xfrm rot="16200000">
              <a:off x="-267518" y="6189082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A480113-0415-FFF7-B2FB-F1DD7DDE8E31}"/>
                </a:ext>
              </a:extLst>
            </p:cNvPr>
            <p:cNvSpPr txBox="1"/>
            <p:nvPr/>
          </p:nvSpPr>
          <p:spPr>
            <a:xfrm rot="16200000">
              <a:off x="6482643" y="-131058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3F7E613-F0AD-E923-975C-145D316D8EE8}"/>
                </a:ext>
              </a:extLst>
            </p:cNvPr>
            <p:cNvSpPr txBox="1"/>
            <p:nvPr/>
          </p:nvSpPr>
          <p:spPr>
            <a:xfrm rot="16200000">
              <a:off x="6482643" y="2994934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47196B9-2777-B436-3225-7B16F13276F9}"/>
                </a:ext>
              </a:extLst>
            </p:cNvPr>
            <p:cNvSpPr txBox="1"/>
            <p:nvPr/>
          </p:nvSpPr>
          <p:spPr>
            <a:xfrm rot="16200000">
              <a:off x="6482643" y="6189082"/>
              <a:ext cx="386388" cy="3076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3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D9BC3CC8-552E-8A17-8FD3-CAA9438D635B}"/>
                </a:ext>
              </a:extLst>
            </p:cNvPr>
            <p:cNvSpPr txBox="1"/>
            <p:nvPr/>
          </p:nvSpPr>
          <p:spPr>
            <a:xfrm>
              <a:off x="79503" y="10056551"/>
              <a:ext cx="12345351" cy="17101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S1</a:t>
              </a:r>
            </a:p>
            <a:p>
              <a:pPr algn="just">
                <a:lnSpc>
                  <a:spcPct val="150000"/>
                </a:lnSpc>
              </a:pPr>
              <a:r>
                <a:rPr lang="en-US" altLang="zh-CN" sz="1800" kern="100" dirty="0">
                  <a:solidFill>
                    <a:srgbClr val="2A2B2E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LC‒MS/MS analysis. </a:t>
              </a:r>
              <a:r>
                <a:rPr lang="en-US" altLang="zh-CN" sz="1800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A, B and C) </a:t>
              </a:r>
              <a:r>
                <a:rPr lang="en-US" altLang="zh-CN" sz="1800" kern="100" dirty="0">
                  <a:solidFill>
                    <a:srgbClr val="2A2B2E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Quantification of quercetin in the  AYR extracts was performed via LC‒MS/MS analysis. </a:t>
              </a:r>
              <a:r>
                <a:rPr lang="en-US" altLang="zh-CN" sz="1800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D, E and F) </a:t>
              </a:r>
              <a:r>
                <a:rPr lang="en-US" altLang="zh-CN" sz="1800" kern="100" dirty="0">
                  <a:solidFill>
                    <a:srgbClr val="2A2B2E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Quercetin concentrations in the AYR </a:t>
              </a:r>
              <a:r>
                <a:rPr lang="en-US" altLang="zh-CN" sz="1800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drug-containing serum</a:t>
              </a:r>
              <a:r>
                <a:rPr lang="en-US" altLang="zh-CN" sz="1800" kern="100" dirty="0">
                  <a:solidFill>
                    <a:srgbClr val="2A2B2E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 were determined through LC‒MS/MS analysis.</a:t>
              </a:r>
              <a:endParaRPr lang="zh-CN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5465A56-580E-5532-00E6-836A31B199FB}"/>
                </a:ext>
              </a:extLst>
            </p:cNvPr>
            <p:cNvSpPr txBox="1"/>
            <p:nvPr/>
          </p:nvSpPr>
          <p:spPr>
            <a:xfrm>
              <a:off x="1887247" y="2527449"/>
              <a:ext cx="1918280" cy="294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499674"/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High dosage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8768B1C-24CC-089C-2667-C6C588DCA71D}"/>
                </a:ext>
              </a:extLst>
            </p:cNvPr>
            <p:cNvSpPr txBox="1"/>
            <p:nvPr/>
          </p:nvSpPr>
          <p:spPr>
            <a:xfrm>
              <a:off x="8729205" y="2527449"/>
              <a:ext cx="1918280" cy="294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499674"/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High dosage</a:t>
              </a:r>
            </a:p>
          </p:txBody>
        </p:sp>
        <p:sp>
          <p:nvSpPr>
            <p:cNvPr id="11" name="文本框 8">
              <a:extLst>
                <a:ext uri="{FF2B5EF4-FFF2-40B4-BE49-F238E27FC236}">
                  <a16:creationId xmlns:a16="http://schemas.microsoft.com/office/drawing/2014/main" id="{C5465A56-580E-5532-00E6-836A31B199FB}"/>
                </a:ext>
              </a:extLst>
            </p:cNvPr>
            <p:cNvSpPr txBox="1"/>
            <p:nvPr/>
          </p:nvSpPr>
          <p:spPr>
            <a:xfrm>
              <a:off x="1887247" y="5754582"/>
              <a:ext cx="2172784" cy="294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499674"/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Medium dosage</a:t>
              </a:r>
            </a:p>
          </p:txBody>
        </p:sp>
        <p:sp>
          <p:nvSpPr>
            <p:cNvPr id="12" name="文本框 8">
              <a:extLst>
                <a:ext uri="{FF2B5EF4-FFF2-40B4-BE49-F238E27FC236}">
                  <a16:creationId xmlns:a16="http://schemas.microsoft.com/office/drawing/2014/main" id="{8A83E87B-829D-737A-B762-263B01689641}"/>
                </a:ext>
              </a:extLst>
            </p:cNvPr>
            <p:cNvSpPr txBox="1"/>
            <p:nvPr/>
          </p:nvSpPr>
          <p:spPr>
            <a:xfrm>
              <a:off x="8729205" y="5754582"/>
              <a:ext cx="21727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499674"/>
              <a:r>
                <a:rPr lang="en-US" altLang="zh-CN" sz="1400" b="1" i="0" dirty="0">
                  <a:solidFill>
                    <a:srgbClr val="3E3D40"/>
                  </a:solidFill>
                  <a:effectLst/>
                  <a:highlight>
                    <a:srgbClr val="F9F6E5"/>
                  </a:highlight>
                  <a:latin typeface="Lucida Grande"/>
                </a:rPr>
                <a:t>Medium</a:t>
              </a:r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 dosage</a:t>
              </a:r>
            </a:p>
          </p:txBody>
        </p:sp>
        <p:sp>
          <p:nvSpPr>
            <p:cNvPr id="13" name="文本框 8">
              <a:extLst>
                <a:ext uri="{FF2B5EF4-FFF2-40B4-BE49-F238E27FC236}">
                  <a16:creationId xmlns:a16="http://schemas.microsoft.com/office/drawing/2014/main" id="{B143BA61-2EC9-54D1-1F43-6B9D61E55B02}"/>
                </a:ext>
              </a:extLst>
            </p:cNvPr>
            <p:cNvSpPr txBox="1"/>
            <p:nvPr/>
          </p:nvSpPr>
          <p:spPr>
            <a:xfrm>
              <a:off x="1878516" y="8914179"/>
              <a:ext cx="1918280" cy="294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499674"/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Low dosage</a:t>
              </a:r>
            </a:p>
          </p:txBody>
        </p:sp>
        <p:sp>
          <p:nvSpPr>
            <p:cNvPr id="14" name="文本框 8">
              <a:extLst>
                <a:ext uri="{FF2B5EF4-FFF2-40B4-BE49-F238E27FC236}">
                  <a16:creationId xmlns:a16="http://schemas.microsoft.com/office/drawing/2014/main" id="{6879A94F-54D3-64DD-8DB7-EB0AEFFB8E7D}"/>
                </a:ext>
              </a:extLst>
            </p:cNvPr>
            <p:cNvSpPr txBox="1"/>
            <p:nvPr/>
          </p:nvSpPr>
          <p:spPr>
            <a:xfrm>
              <a:off x="8729205" y="8914179"/>
              <a:ext cx="1918280" cy="294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indent="499674"/>
              <a:r>
                <a:rPr lang="en-US" altLang="zh-CN" sz="1311" b="1" dirty="0">
                  <a:latin typeface="Arial" panose="020B0604020202020204" pitchFamily="34" charset="0"/>
                  <a:cs typeface="Arial" panose="020B0604020202020204" pitchFamily="34" charset="0"/>
                </a:rPr>
                <a:t>Low dosag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178755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F9BB9754-ABA9-7F21-3D88-F1A9C1FB736A}"/>
              </a:ext>
            </a:extLst>
          </p:cNvPr>
          <p:cNvGrpSpPr/>
          <p:nvPr/>
        </p:nvGrpSpPr>
        <p:grpSpPr>
          <a:xfrm>
            <a:off x="812143" y="2246435"/>
            <a:ext cx="6180673" cy="5801904"/>
            <a:chOff x="91174" y="2246435"/>
            <a:chExt cx="6180673" cy="5801904"/>
          </a:xfrm>
        </p:grpSpPr>
        <p:graphicFrame>
          <p:nvGraphicFramePr>
            <p:cNvPr id="3" name="图表 2">
              <a:extLst>
                <a:ext uri="{FF2B5EF4-FFF2-40B4-BE49-F238E27FC236}">
                  <a16:creationId xmlns:a16="http://schemas.microsoft.com/office/drawing/2014/main" id="{68654172-8532-C2B9-3F7B-6461DEB540DB}"/>
                </a:ext>
              </a:extLst>
            </p:cNvPr>
            <p:cNvGraphicFramePr/>
            <p:nvPr/>
          </p:nvGraphicFramePr>
          <p:xfrm>
            <a:off x="513261" y="2426678"/>
            <a:ext cx="5690077" cy="40495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EDCC7F1C-AD15-0F77-B814-6F1F74C7DC22}"/>
                </a:ext>
              </a:extLst>
            </p:cNvPr>
            <p:cNvSpPr txBox="1"/>
            <p:nvPr/>
          </p:nvSpPr>
          <p:spPr>
            <a:xfrm>
              <a:off x="1000866" y="7169188"/>
              <a:ext cx="5270981" cy="8791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FIGURE S2</a:t>
              </a:r>
            </a:p>
            <a:p>
              <a:pPr algn="just">
                <a:lnSpc>
                  <a:spcPct val="150000"/>
                </a:lnSpc>
              </a:pPr>
              <a:r>
                <a:rPr lang="en-US" altLang="zh-CN" sz="1800" kern="100" dirty="0">
                  <a:solidFill>
                    <a:srgbClr val="2A2B2E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</a:rPr>
                <a:t>Quercetin standard curve</a:t>
              </a:r>
              <a:endParaRPr lang="zh-CN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C5BEFF1-F2CC-EDFB-0A5B-132932A61B8E}"/>
                </a:ext>
              </a:extLst>
            </p:cNvPr>
            <p:cNvSpPr txBox="1"/>
            <p:nvPr/>
          </p:nvSpPr>
          <p:spPr>
            <a:xfrm>
              <a:off x="2209801" y="6476268"/>
              <a:ext cx="406204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oncentration（</a:t>
              </a:r>
              <a:r>
                <a:rPr lang="en-US" altLang="zh-CN" sz="1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g/mL</a:t>
              </a:r>
              <a:r>
                <a:rPr lang="zh-CN" altLang="en-US" sz="18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）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6803C58-77A2-0A1B-9AE4-80A294387CA1}"/>
                </a:ext>
              </a:extLst>
            </p:cNvPr>
            <p:cNvSpPr txBox="1"/>
            <p:nvPr/>
          </p:nvSpPr>
          <p:spPr>
            <a:xfrm rot="16200000">
              <a:off x="-1100156" y="3437765"/>
              <a:ext cx="27519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zh-CN" altLang="en-US" dirty="0">
                  <a:latin typeface="Arial" panose="020B0604020202020204" pitchFamily="34" charset="0"/>
                  <a:cs typeface="Arial" panose="020B0604020202020204" pitchFamily="34" charset="0"/>
                </a:rPr>
                <a:t>ntens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14947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387</TotalTime>
  <Words>107</Words>
  <Application>Microsoft Office PowerPoint</Application>
  <PresentationFormat>B4 (ISO) Paper (250x353 mm)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等线</vt:lpstr>
      <vt:lpstr>Lucida Grande</vt:lpstr>
      <vt:lpstr>Arial</vt:lpstr>
      <vt:lpstr>Calibri</vt:lpstr>
      <vt:lpstr>Calibri Light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 qianqian</dc:creator>
  <cp:lastModifiedBy>Naimeng Liu</cp:lastModifiedBy>
  <cp:revision>60</cp:revision>
  <dcterms:created xsi:type="dcterms:W3CDTF">2022-07-15T14:20:28Z</dcterms:created>
  <dcterms:modified xsi:type="dcterms:W3CDTF">2024-07-16T11:59:56Z</dcterms:modified>
</cp:coreProperties>
</file>